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304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106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903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299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462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5545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288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321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0467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1232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4686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199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310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AEDC7A0-63BE-4F09-810A-CBC83406BEBC}"/>
              </a:ext>
            </a:extLst>
          </p:cNvPr>
          <p:cNvSpPr txBox="1"/>
          <p:nvPr/>
        </p:nvSpPr>
        <p:spPr>
          <a:xfrm>
            <a:off x="28575" y="2190750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sFigure5.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ultivariate cox hazard proportional analysis for Relapse-free survival of the CRC patients.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e performed multivariate Cox regression analysis to compute a HR according to age ≥ 70, male sex, depth of invasion (pT4), the presence of LN metastasis, low hemoglobin, GPS 1-2,  NLR (≥ 5), PLR (≥150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w transferrin by using method “enter”.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93079563-DFE8-4428-AE82-DDCC550F6C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75" y="0"/>
            <a:ext cx="6829425" cy="2190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4865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72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澤山 浩</dc:creator>
  <cp:lastModifiedBy>澤山 浩</cp:lastModifiedBy>
  <cp:revision>11</cp:revision>
  <dcterms:created xsi:type="dcterms:W3CDTF">2020-05-05T12:02:23Z</dcterms:created>
  <dcterms:modified xsi:type="dcterms:W3CDTF">2020-09-27T10:42:47Z</dcterms:modified>
</cp:coreProperties>
</file>